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5E4F9E-917D-4C9E-9330-ACCBEC1E4A1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483400-D978-4759-BAC9-D079CED5236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6C6783-F5E2-49E9-BF8C-4E30CC51090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C3A7AF-C61C-48A0-8B6F-D245A529663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87A6D5-A5F5-4F8B-A4B9-43F56A7EACC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431E88-1D85-4C31-BE2F-62DA3395F3F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15928A-72E0-488C-A5DD-CC099C39710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D25CA5-B41E-4F5D-A052-0BAF92ACC5E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E7F6D6-E027-4B94-BFF9-2A6144F48C5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8F4666-02DA-4243-8B59-22163AD894F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465341-E285-4BC8-ADC7-81BC9B4B65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A9ED00-F3E3-4EB6-B7E5-6E9984F822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53B4042-2FF9-4D05-9D61-A7187AF3102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6012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rcRect l="11307" t="41484" r="14098" b="20314"/>
          <a:stretch/>
        </p:blipFill>
        <p:spPr>
          <a:xfrm>
            <a:off x="1984320" y="1817640"/>
            <a:ext cx="2881440" cy="104796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2"/>
          <a:srcRect l="2838" t="19869" r="2838" b="60024"/>
          <a:stretch/>
        </p:blipFill>
        <p:spPr>
          <a:xfrm>
            <a:off x="1984320" y="2922480"/>
            <a:ext cx="2881440" cy="263520"/>
          </a:xfrm>
          <a:prstGeom prst="rect">
            <a:avLst/>
          </a:prstGeom>
          <a:ln w="0">
            <a:noFill/>
          </a:ln>
        </p:spPr>
      </p:pic>
      <p:sp>
        <p:nvSpPr>
          <p:cNvPr id="44" name="ZoneTexte 46"/>
          <p:cNvSpPr/>
          <p:nvPr/>
        </p:nvSpPr>
        <p:spPr>
          <a:xfrm>
            <a:off x="2152800" y="1139760"/>
            <a:ext cx="22356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ZoneTexte 47"/>
          <p:cNvSpPr/>
          <p:nvPr/>
        </p:nvSpPr>
        <p:spPr>
          <a:xfrm>
            <a:off x="2667960" y="1168560"/>
            <a:ext cx="25380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ZoneTexte 48"/>
          <p:cNvSpPr/>
          <p:nvPr/>
        </p:nvSpPr>
        <p:spPr>
          <a:xfrm>
            <a:off x="2899800" y="1139760"/>
            <a:ext cx="25380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ZoneTexte 49"/>
          <p:cNvSpPr/>
          <p:nvPr/>
        </p:nvSpPr>
        <p:spPr>
          <a:xfrm>
            <a:off x="3144240" y="1139760"/>
            <a:ext cx="25380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ZoneTexte 50"/>
          <p:cNvSpPr/>
          <p:nvPr/>
        </p:nvSpPr>
        <p:spPr>
          <a:xfrm>
            <a:off x="3610800" y="1139760"/>
            <a:ext cx="25380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ZoneTexte 54"/>
          <p:cNvSpPr/>
          <p:nvPr/>
        </p:nvSpPr>
        <p:spPr>
          <a:xfrm>
            <a:off x="3383640" y="1139760"/>
            <a:ext cx="25380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ZoneTexte 55"/>
          <p:cNvSpPr/>
          <p:nvPr/>
        </p:nvSpPr>
        <p:spPr>
          <a:xfrm>
            <a:off x="1628640" y="1187280"/>
            <a:ext cx="468360" cy="67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ICP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ICP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ICP2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ICP2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3784320" y="1620720"/>
            <a:ext cx="362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TF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4083120" y="1619280"/>
            <a:ext cx="431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TF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4292640" y="1619280"/>
            <a:ext cx="576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TR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2977920" y="898560"/>
            <a:ext cx="627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wt AAV-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2060640" y="1116000"/>
            <a:ext cx="2305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298"/>
          <p:cNvSpPr/>
          <p:nvPr/>
        </p:nvSpPr>
        <p:spPr>
          <a:xfrm>
            <a:off x="4975200" y="2233440"/>
            <a:ext cx="83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Rep 5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296"/>
          <p:cNvSpPr/>
          <p:nvPr/>
        </p:nvSpPr>
        <p:spPr>
          <a:xfrm>
            <a:off x="4994280" y="2008080"/>
            <a:ext cx="719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Rep 7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299"/>
          <p:cNvSpPr/>
          <p:nvPr/>
        </p:nvSpPr>
        <p:spPr>
          <a:xfrm>
            <a:off x="4975200" y="2411280"/>
            <a:ext cx="719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Rep 4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9" name="Connecteur droit avec flèche 24"/>
          <p:cNvCxnSpPr/>
          <p:nvPr/>
        </p:nvCxnSpPr>
        <p:spPr>
          <a:xfrm flipH="1" flipV="1">
            <a:off x="4903200" y="2520720"/>
            <a:ext cx="13860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60" name="Connecteur droit avec flèche 25"/>
          <p:cNvCxnSpPr/>
          <p:nvPr/>
        </p:nvCxnSpPr>
        <p:spPr>
          <a:xfrm flipH="1" flipV="1">
            <a:off x="4903200" y="2351880"/>
            <a:ext cx="138600" cy="2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61" name="Connecteur droit avec flèche 27"/>
          <p:cNvCxnSpPr/>
          <p:nvPr/>
        </p:nvCxnSpPr>
        <p:spPr>
          <a:xfrm flipH="1" flipV="1">
            <a:off x="4903200" y="2133360"/>
            <a:ext cx="13860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62" name=""/>
          <p:cNvSpPr/>
          <p:nvPr/>
        </p:nvSpPr>
        <p:spPr>
          <a:xfrm>
            <a:off x="673200" y="3610080"/>
            <a:ext cx="5635440" cy="100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upplementary Figure 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. Hela cells were transfected with the indicated plasmids and, 6 hours later, infected with wt AAV-2 particles at an MOI of 1000 particles/cell. Cell extracts were prepared 48 hours post-infection and analyzed by Western blot using an anti-Rep antibody. The same amount of samples was loaded on a separate gel to analyze protein content using an anti-tubulin antibody. pTF4: plasmid expressing ICP0, ICP4, ICP22 and ICP27; pTF3: plasmid expressing ICP0, ICP4 and ICP22. CTRL: untreated  HeLa cells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299"/>
          <p:cNvSpPr/>
          <p:nvPr/>
        </p:nvSpPr>
        <p:spPr>
          <a:xfrm>
            <a:off x="4869000" y="2954160"/>
            <a:ext cx="718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ubul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2-28T15:43:59Z</dcterms:created>
  <dc:creator>asalvett</dc:creator>
  <dc:description/>
  <dc:language>en-US</dc:language>
  <cp:lastModifiedBy>asalvett</cp:lastModifiedBy>
  <dcterms:modified xsi:type="dcterms:W3CDTF">2009-02-05T13:47:05Z</dcterms:modified>
  <cp:revision>11</cp:revision>
  <dc:subject/>
  <dc:title>Diapositive 1</dc:title>
</cp:coreProperties>
</file>